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660" r:id="rId2"/>
    <p:sldId id="661" r:id="rId3"/>
    <p:sldId id="674" r:id="rId4"/>
    <p:sldId id="675" r:id="rId5"/>
    <p:sldId id="681" r:id="rId6"/>
    <p:sldId id="676" r:id="rId7"/>
    <p:sldId id="677" r:id="rId8"/>
    <p:sldId id="678" r:id="rId9"/>
    <p:sldId id="679" r:id="rId10"/>
    <p:sldId id="680" r:id="rId11"/>
    <p:sldId id="683" r:id="rId12"/>
    <p:sldId id="684" r:id="rId13"/>
    <p:sldId id="685" r:id="rId14"/>
    <p:sldId id="686" r:id="rId15"/>
    <p:sldId id="687" r:id="rId16"/>
    <p:sldId id="688" r:id="rId17"/>
    <p:sldId id="689" r:id="rId18"/>
    <p:sldId id="690" r:id="rId19"/>
    <p:sldId id="691" r:id="rId20"/>
    <p:sldId id="692" r:id="rId2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43" autoAdjust="0"/>
    <p:restoredTop sz="94660"/>
  </p:normalViewPr>
  <p:slideViewPr>
    <p:cSldViewPr snapToGrid="0">
      <p:cViewPr varScale="1">
        <p:scale>
          <a:sx n="81" d="100"/>
          <a:sy n="81" d="100"/>
        </p:scale>
        <p:origin x="754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50A812-A544-49A9-9AD4-726EBAE3D271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936EE1-D568-4DAA-AB0F-FC54399560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01109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9256A3-DC1F-2398-EBB8-2355C2BF29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A25788E-929C-F7E9-87A1-D56A34D729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29E0EA-AA63-6A47-3455-095B110391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23C1CE-99A4-9FBA-B86A-E8607EA01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F5D028-8578-17B5-547C-95C39E6E9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6621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ACBE6B-8C4A-2F0F-0187-E33DF94CAB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11C327D-A00A-2B47-A387-81A386A6E3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EC3E25-D739-B970-5530-6E038DD59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63144F-DA0D-2046-9F06-D59A06105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959403-E67C-CE66-B15C-A02F19E4C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256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E9CE073-7B36-331F-C9B8-14BE17DBFF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B4BA75B-18D7-3257-0D70-EBD2659B02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AD2588-5DA3-60D0-765E-CB37B2C3D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A750CB-4200-A8AB-1411-3A3CABFF3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0E97BD-1D01-3611-7FFA-46EAEF0E9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3390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6E0A46-0FC0-D58A-465E-3F8A7E6035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B49B6D8-A287-2407-5582-5456CFDC7B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B3342A-8603-11EA-6C8A-7D66B4549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CDCFDB-8B3F-E88F-AE0B-132B390E8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0739DE-3526-C127-29B6-04F40E0EF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7431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B181FD-E9AC-1B76-45F6-425BCA6716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75E4F29-AD8C-5F35-B5EA-50E637F3D6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F1F0B8-D350-8E8E-AB38-56623367E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9CB451-DC3A-373B-F58A-443A8EFC19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4D0174-F0F4-E8B3-AEAD-5186556A9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9352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B2A909-664E-7C64-0741-D638A1F3AF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E70173F-1B7C-5613-DCC5-FAEE299577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4BDB620-7043-F9EF-A1CC-C90AE1CE69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5B074C-210D-617B-9F9E-6B13BF867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7E6C40F-DF5E-6B92-B6A4-E58AE39C8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51C603-1CB2-97B8-AD74-F54D30A87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6456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413A69-9C6C-5C62-AE21-29F7784FEE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5E666E9-47EF-5690-2423-254FE7A2F7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22E37DA-3136-273E-3450-D97023B247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2E1B066-8D34-4499-60A0-E19AE44194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925A530-75C2-EF72-279E-BDCDA7D534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665BD60-6EA2-E041-59DA-141FDDF1D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CADF89C-B955-0C7C-ECF2-BD5C39078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BDAD083-548E-1F0E-7948-050743C57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057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46127E-A2EB-C02E-F01D-6D99582F47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B616F34-BB5A-F4EA-DF27-DF566AFF9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E303F1D-1096-181F-3E73-DC48B55A1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131EDD1-528A-2738-AC0B-8DA95E904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2995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E37AB6D-E80D-75EF-2935-9E46384A4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4228695-B049-C0D1-80FC-CD093A528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D3D9B35-5974-D8B1-2ECD-26CB46C1F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197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DAEEF2-7B6E-8161-E847-17A77C8D8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006A986-0A46-62F8-5748-AE5328BD77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51A7CA-DC3C-0E9C-3060-C3645C88B9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28F935-211A-C88D-A9D5-340F5A630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D59747D-CAB3-09DB-BC93-D3AFBAAFE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CDB4AE-BB58-A245-7022-D33E62C32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1239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4DED51-8878-F613-D705-09C218700E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92E61A2-36D2-3017-FC06-8D081A8662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12DB6F9-BAE2-84B2-A8AF-863234C958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3859C80-28D2-FF4B-F1E9-A6EF34763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FD5F3A6-315F-C681-8C2C-C75563DDF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E2B3B5C-D544-F908-BBE0-D599D1F66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4940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13DCE5A-1FF3-4FE7-58E0-534919A06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7F71BC5-BCDC-585E-CBBC-72BBB3B37B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4E5BA4-81FC-62D9-5250-BE4D8637CA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296526-C9D4-4CE3-B803-52FF5A81FA3B}" type="datetimeFigureOut">
              <a:rPr lang="zh-CN" altLang="en-US" smtClean="0"/>
              <a:t>2023-01-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534618-414D-0FF8-09A2-CEFF52632D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29A51E-83FE-E7F9-C997-69AEC9B6C6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6C531-410B-4C9D-9346-75A8BF6BA0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9028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A4951992-C2BC-AF1B-EFDC-2961E4FA40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3267076"/>
              </p:ext>
            </p:extLst>
          </p:nvPr>
        </p:nvGraphicFramePr>
        <p:xfrm>
          <a:off x="321276" y="1165653"/>
          <a:ext cx="11162270" cy="5188945"/>
        </p:xfrm>
        <a:graphic>
          <a:graphicData uri="http://schemas.openxmlformats.org/drawingml/2006/table">
            <a:tbl>
              <a:tblPr firstRow="1" firstCol="1" bandRow="1"/>
              <a:tblGrid>
                <a:gridCol w="1257998">
                  <a:extLst>
                    <a:ext uri="{9D8B030D-6E8A-4147-A177-3AD203B41FA5}">
                      <a16:colId xmlns:a16="http://schemas.microsoft.com/office/drawing/2014/main" val="3976130277"/>
                    </a:ext>
                  </a:extLst>
                </a:gridCol>
                <a:gridCol w="3633998">
                  <a:extLst>
                    <a:ext uri="{9D8B030D-6E8A-4147-A177-3AD203B41FA5}">
                      <a16:colId xmlns:a16="http://schemas.microsoft.com/office/drawing/2014/main" val="2736692400"/>
                    </a:ext>
                  </a:extLst>
                </a:gridCol>
                <a:gridCol w="3135137">
                  <a:extLst>
                    <a:ext uri="{9D8B030D-6E8A-4147-A177-3AD203B41FA5}">
                      <a16:colId xmlns:a16="http://schemas.microsoft.com/office/drawing/2014/main" val="2603508552"/>
                    </a:ext>
                  </a:extLst>
                </a:gridCol>
                <a:gridCol w="3135137">
                  <a:extLst>
                    <a:ext uri="{9D8B030D-6E8A-4147-A177-3AD203B41FA5}">
                      <a16:colId xmlns:a16="http://schemas.microsoft.com/office/drawing/2014/main" val="2961101436"/>
                    </a:ext>
                  </a:extLst>
                </a:gridCol>
              </a:tblGrid>
              <a:tr h="511457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  <a:tabLst>
                          <a:tab pos="620395" algn="l"/>
                        </a:tabLst>
                      </a:pPr>
                      <a:r>
                        <a:rPr lang="en-US" sz="2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ene</a:t>
                      </a:r>
                      <a:endParaRPr lang="zh-CN" sz="2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orward primer</a:t>
                      </a:r>
                      <a:endParaRPr lang="zh-CN" sz="2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verse primer</a:t>
                      </a:r>
                      <a:endParaRPr lang="zh-CN" sz="2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altLang="zh-CN" sz="2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ferences</a:t>
                      </a:r>
                      <a:endParaRPr lang="zh-CN" altLang="en-US" sz="20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460678"/>
                  </a:ext>
                </a:extLst>
              </a:tr>
              <a:tr h="447526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Pase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TTCCCATCGGTGGATGCTAC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AAGCCGAATTGAACTGCGTCA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Dong et al., 2019)</a:t>
                      </a:r>
                      <a:endParaRPr lang="zh-CN" sz="1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4106439"/>
                  </a:ext>
                </a:extLst>
              </a:tr>
              <a:tr h="447526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BSS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33350" indent="-133350"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CCTCAGCACCAACAAACACC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TGGATTCACGTCAGATGCAG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Dong et al., 2019)</a:t>
                      </a:r>
                      <a:endParaRPr lang="zh-CN" sz="1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4914460"/>
                  </a:ext>
                </a:extLst>
              </a:tr>
              <a:tr h="447526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BE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kern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GTGAGCCATCTGCATTATTAG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kern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AAGTGGGCGACCCTCATAG</a:t>
                      </a:r>
                      <a:endParaRPr lang="zh-CN" sz="2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Dong et al., 2019)</a:t>
                      </a:r>
                      <a:endParaRPr lang="zh-CN" sz="1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448450"/>
                  </a:ext>
                </a:extLst>
              </a:tr>
              <a:tr h="447526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PR-1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GAGATCCACAAGTAGGTGAAGC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TCTTGCCAGAGCAACTCG</a:t>
                      </a:r>
                      <a:endParaRPr lang="zh-CN" sz="2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6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alio</a:t>
                      </a: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et al., 2020)</a:t>
                      </a:r>
                      <a:endParaRPr lang="zh-CN" sz="1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4881166"/>
                  </a:ext>
                </a:extLst>
              </a:tr>
              <a:tr h="447526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R-1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CCGGCCTTATTTCACATTC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CCATCTTCATCATCTGCAA</a:t>
                      </a:r>
                      <a:endParaRPr lang="zh-CN" sz="2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Dalio et al., 2020)</a:t>
                      </a:r>
                      <a:endParaRPr lang="zh-CN" sz="1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1361309"/>
                  </a:ext>
                </a:extLst>
              </a:tr>
              <a:tr h="447526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R-3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TCACCACCAACATCATCAA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AGCAAGTCGCAGTACCTC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Dalio et al., 2020)</a:t>
                      </a:r>
                      <a:endParaRPr lang="zh-CN" sz="1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815603"/>
                  </a:ext>
                </a:extLst>
              </a:tr>
              <a:tr h="447526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RF1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CAAATGTTGGTCCGTTTC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CGCTGTCTTCCACGATTCA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Dalio et al., 2020)</a:t>
                      </a:r>
                      <a:endParaRPr lang="zh-CN" sz="1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3342806"/>
                  </a:ext>
                </a:extLst>
              </a:tr>
              <a:tr h="447526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CC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266700"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ATGCTGCACATCGGCTAGT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CCACCTGAATACGGCAGAC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Dalio et al., 2020)</a:t>
                      </a:r>
                      <a:endParaRPr lang="zh-CN" sz="1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6078505"/>
                  </a:ext>
                </a:extLst>
              </a:tr>
              <a:tr h="447526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YC2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GGATCTACCGACGTGGTCT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CGTCCGGAGAGCTAAAGT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Dalio et al., 2020)</a:t>
                      </a:r>
                      <a:endParaRPr lang="zh-CN" sz="16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0366137"/>
                  </a:ext>
                </a:extLst>
              </a:tr>
              <a:tr h="339046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2000" i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usa25SrRNA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CATTGTCAGGTGGGGAGTT</a:t>
                      </a:r>
                      <a:endParaRPr lang="zh-CN" sz="20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TTTTGTTCCACACGAGATT</a:t>
                      </a:r>
                      <a:endParaRPr lang="zh-CN" sz="2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Berg et al., 2007; Wu et al., 2013)</a:t>
                      </a:r>
                      <a:endParaRPr lang="zh-CN" sz="1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9693501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B4235CBD-3B3B-2388-37A9-8A482945444D}"/>
              </a:ext>
            </a:extLst>
          </p:cNvPr>
          <p:cNvSpPr txBox="1"/>
          <p:nvPr/>
        </p:nvSpPr>
        <p:spPr>
          <a:xfrm>
            <a:off x="3633319" y="968279"/>
            <a:ext cx="2616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2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zh-CN" sz="24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7C74D4DF-F355-7922-FDB5-7295B4E4DE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047" y="512968"/>
            <a:ext cx="685854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Table 1. The detailed primer sequences used in this study</a:t>
            </a:r>
            <a:endParaRPr kumimoji="0" lang="en-US" altLang="zh-CN" sz="2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32954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31848A15-C563-B105-C529-743720F9EB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583967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8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5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6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2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9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8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6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7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3F8F5E5F-C205-EB68-06F4-A67A47E44A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37664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7BF94B5-0E9E-98B3-DE52-EA01910B4B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1405586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5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6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8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9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2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 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5.5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1 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F968E56F-5215-B5B4-1B16-06DEF059AC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846765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7BF94B5-0E9E-98B3-DE52-EA01910B4B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6829972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8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02.6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91.7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24.6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43.9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404.3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29.4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2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9.6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4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6.6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6.6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4.4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8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3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76.0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6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8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F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199E07DE-1635-8A08-1B95-447CF2863A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899218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7BF94B5-0E9E-98B3-DE52-EA01910B4B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9526950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5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4.3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9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5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3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7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3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8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3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2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195BC310-D30D-BCAB-B46B-E6700C4D6D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740762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7BF94B5-0E9E-98B3-DE52-EA01910B4B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7981696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1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8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8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9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1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A0C9B479-1111-4ABC-D976-6E9AC50F1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48528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7BF94B5-0E9E-98B3-DE52-EA01910B4B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6767325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1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1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3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6.1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8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0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9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6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1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2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1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5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2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40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8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5118127C-125B-D047-B4D9-57F80D499D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620682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7BF94B5-0E9E-98B3-DE52-EA01910B4B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9046708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5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6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2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2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2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1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34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4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R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03F6FAF8-B3B9-9A2A-C172-2CD5A5F95B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398914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7BF94B5-0E9E-98B3-DE52-EA01910B4B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1534688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8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4.7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8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2.7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7.5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8.8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8.8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7.7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4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5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7.8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5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9.4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2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9.9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9.4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9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9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0B892C77-C273-7712-61D3-4DE5AD91CF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197951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7BF94B5-0E9E-98B3-DE52-EA01910B4B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6543860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8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1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8.8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3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4.2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8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4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2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5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5.3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4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41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2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59F06E05-D82E-F153-6EF8-76BA3D0EF6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591766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7BF94B5-0E9E-98B3-DE52-EA01910B4B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2759428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9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6.8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4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1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3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6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3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4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8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2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6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35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7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92D33D0C-16B7-45BA-7B68-7AF1C29F3B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52927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70C43A26-BD2B-84AD-2A35-9CC2D859837F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640539957"/>
              </p:ext>
            </p:extLst>
          </p:nvPr>
        </p:nvGraphicFramePr>
        <p:xfrm>
          <a:off x="322635" y="389106"/>
          <a:ext cx="11546730" cy="5859636"/>
        </p:xfrm>
        <a:graphic>
          <a:graphicData uri="http://schemas.openxmlformats.org/drawingml/2006/table">
            <a:tbl>
              <a:tblPr firstRow="1" firstCol="1" bandRow="1"/>
              <a:tblGrid>
                <a:gridCol w="1099765">
                  <a:extLst>
                    <a:ext uri="{9D8B030D-6E8A-4147-A177-3AD203B41FA5}">
                      <a16:colId xmlns:a16="http://schemas.microsoft.com/office/drawing/2014/main" val="970764973"/>
                    </a:ext>
                  </a:extLst>
                </a:gridCol>
                <a:gridCol w="1226581">
                  <a:extLst>
                    <a:ext uri="{9D8B030D-6E8A-4147-A177-3AD203B41FA5}">
                      <a16:colId xmlns:a16="http://schemas.microsoft.com/office/drawing/2014/main" val="745356919"/>
                    </a:ext>
                  </a:extLst>
                </a:gridCol>
                <a:gridCol w="615356">
                  <a:extLst>
                    <a:ext uri="{9D8B030D-6E8A-4147-A177-3AD203B41FA5}">
                      <a16:colId xmlns:a16="http://schemas.microsoft.com/office/drawing/2014/main" val="1593770924"/>
                    </a:ext>
                  </a:extLst>
                </a:gridCol>
                <a:gridCol w="619643">
                  <a:extLst>
                    <a:ext uri="{9D8B030D-6E8A-4147-A177-3AD203B41FA5}">
                      <a16:colId xmlns:a16="http://schemas.microsoft.com/office/drawing/2014/main" val="3853865806"/>
                    </a:ext>
                  </a:extLst>
                </a:gridCol>
                <a:gridCol w="619643">
                  <a:extLst>
                    <a:ext uri="{9D8B030D-6E8A-4147-A177-3AD203B41FA5}">
                      <a16:colId xmlns:a16="http://schemas.microsoft.com/office/drawing/2014/main" val="83777445"/>
                    </a:ext>
                  </a:extLst>
                </a:gridCol>
                <a:gridCol w="622861">
                  <a:extLst>
                    <a:ext uri="{9D8B030D-6E8A-4147-A177-3AD203B41FA5}">
                      <a16:colId xmlns:a16="http://schemas.microsoft.com/office/drawing/2014/main" val="1108479966"/>
                    </a:ext>
                  </a:extLst>
                </a:gridCol>
                <a:gridCol w="622861">
                  <a:extLst>
                    <a:ext uri="{9D8B030D-6E8A-4147-A177-3AD203B41FA5}">
                      <a16:colId xmlns:a16="http://schemas.microsoft.com/office/drawing/2014/main" val="3100490887"/>
                    </a:ext>
                  </a:extLst>
                </a:gridCol>
                <a:gridCol w="468486">
                  <a:extLst>
                    <a:ext uri="{9D8B030D-6E8A-4147-A177-3AD203B41FA5}">
                      <a16:colId xmlns:a16="http://schemas.microsoft.com/office/drawing/2014/main" val="659048811"/>
                    </a:ext>
                  </a:extLst>
                </a:gridCol>
                <a:gridCol w="555322">
                  <a:extLst>
                    <a:ext uri="{9D8B030D-6E8A-4147-A177-3AD203B41FA5}">
                      <a16:colId xmlns:a16="http://schemas.microsoft.com/office/drawing/2014/main" val="2299042869"/>
                    </a:ext>
                  </a:extLst>
                </a:gridCol>
                <a:gridCol w="557466">
                  <a:extLst>
                    <a:ext uri="{9D8B030D-6E8A-4147-A177-3AD203B41FA5}">
                      <a16:colId xmlns:a16="http://schemas.microsoft.com/office/drawing/2014/main" val="1456266514"/>
                    </a:ext>
                  </a:extLst>
                </a:gridCol>
                <a:gridCol w="598205">
                  <a:extLst>
                    <a:ext uri="{9D8B030D-6E8A-4147-A177-3AD203B41FA5}">
                      <a16:colId xmlns:a16="http://schemas.microsoft.com/office/drawing/2014/main" val="2297192646"/>
                    </a:ext>
                  </a:extLst>
                </a:gridCol>
                <a:gridCol w="598205">
                  <a:extLst>
                    <a:ext uri="{9D8B030D-6E8A-4147-A177-3AD203B41FA5}">
                      <a16:colId xmlns:a16="http://schemas.microsoft.com/office/drawing/2014/main" val="122127702"/>
                    </a:ext>
                  </a:extLst>
                </a:gridCol>
                <a:gridCol w="500648">
                  <a:extLst>
                    <a:ext uri="{9D8B030D-6E8A-4147-A177-3AD203B41FA5}">
                      <a16:colId xmlns:a16="http://schemas.microsoft.com/office/drawing/2014/main" val="2271230560"/>
                    </a:ext>
                  </a:extLst>
                </a:gridCol>
                <a:gridCol w="591770">
                  <a:extLst>
                    <a:ext uri="{9D8B030D-6E8A-4147-A177-3AD203B41FA5}">
                      <a16:colId xmlns:a16="http://schemas.microsoft.com/office/drawing/2014/main" val="4205600978"/>
                    </a:ext>
                  </a:extLst>
                </a:gridCol>
                <a:gridCol w="591770">
                  <a:extLst>
                    <a:ext uri="{9D8B030D-6E8A-4147-A177-3AD203B41FA5}">
                      <a16:colId xmlns:a16="http://schemas.microsoft.com/office/drawing/2014/main" val="3195713032"/>
                    </a:ext>
                  </a:extLst>
                </a:gridCol>
                <a:gridCol w="472774">
                  <a:extLst>
                    <a:ext uri="{9D8B030D-6E8A-4147-A177-3AD203B41FA5}">
                      <a16:colId xmlns:a16="http://schemas.microsoft.com/office/drawing/2014/main" val="3762802277"/>
                    </a:ext>
                  </a:extLst>
                </a:gridCol>
                <a:gridCol w="592687">
                  <a:extLst>
                    <a:ext uri="{9D8B030D-6E8A-4147-A177-3AD203B41FA5}">
                      <a16:colId xmlns:a16="http://schemas.microsoft.com/office/drawing/2014/main" val="1286592139"/>
                    </a:ext>
                  </a:extLst>
                </a:gridCol>
                <a:gridCol w="426677">
                  <a:extLst>
                    <a:ext uri="{9D8B030D-6E8A-4147-A177-3AD203B41FA5}">
                      <a16:colId xmlns:a16="http://schemas.microsoft.com/office/drawing/2014/main" val="2896914971"/>
                    </a:ext>
                  </a:extLst>
                </a:gridCol>
                <a:gridCol w="166010">
                  <a:extLst>
                    <a:ext uri="{9D8B030D-6E8A-4147-A177-3AD203B41FA5}">
                      <a16:colId xmlns:a16="http://schemas.microsoft.com/office/drawing/2014/main" val="601744881"/>
                    </a:ext>
                  </a:extLst>
                </a:gridCol>
              </a:tblGrid>
              <a:tr h="474221">
                <a:tc rowSpan="3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Cultivar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Treatment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d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d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4d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2d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05054158"/>
                  </a:ext>
                </a:extLst>
              </a:tr>
              <a:tr h="54774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oot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orm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oot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orm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oot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orm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oot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orm</a:t>
                      </a:r>
                      <a:endParaRPr lang="zh-CN" altLang="en-US" sz="1800" b="0" dirty="0"/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877301"/>
                  </a:ext>
                </a:extLst>
              </a:tr>
              <a:tr h="45214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zh-CN" sz="18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077921"/>
                  </a:ext>
                </a:extLst>
              </a:tr>
              <a:tr h="547743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razilian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zh-CN" sz="18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93257"/>
                  </a:ext>
                </a:extLst>
              </a:tr>
              <a:tr h="547743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razilian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4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zh-CN" sz="18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0247915"/>
                  </a:ext>
                </a:extLst>
              </a:tr>
              <a:tr h="547743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razilian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4+R1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zh-CN" sz="18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288961"/>
                  </a:ext>
                </a:extLst>
              </a:tr>
              <a:tr h="547743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razilian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4+R2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zh-CN" sz="18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1563565"/>
                  </a:ext>
                </a:extLst>
              </a:tr>
              <a:tr h="547743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unjiao No.1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zh-CN" sz="18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1596460"/>
                  </a:ext>
                </a:extLst>
              </a:tr>
              <a:tr h="547743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unjiao No.1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4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zh-CN" sz="18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3952861"/>
                  </a:ext>
                </a:extLst>
              </a:tr>
              <a:tr h="547743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unjiao No.1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4+R1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zh-CN" sz="18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608527"/>
                  </a:ext>
                </a:extLst>
              </a:tr>
              <a:tr h="547743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unjiao No.1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4+R2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highlight>
                            <a:srgbClr val="FF0000"/>
                          </a:highlight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+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800" b="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-</a:t>
                      </a:r>
                      <a:endParaRPr lang="zh-CN" sz="1800" b="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zh-CN" sz="18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6644577"/>
                  </a:ext>
                </a:extLst>
              </a:tr>
            </a:tbl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4E081590-9C17-61E4-53FE-ACB739662BD8}"/>
              </a:ext>
            </a:extLst>
          </p:cNvPr>
          <p:cNvSpPr txBox="1"/>
          <p:nvPr/>
        </p:nvSpPr>
        <p:spPr>
          <a:xfrm>
            <a:off x="322635" y="0"/>
            <a:ext cx="68466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Table 2. The TR4 observation results </a:t>
            </a:r>
            <a:endParaRPr lang="zh-CN" altLang="zh-CN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Rectangle 1">
            <a:extLst>
              <a:ext uri="{FF2B5EF4-FFF2-40B4-BE49-F238E27FC236}">
                <a16:creationId xmlns:a16="http://schemas.microsoft.com/office/drawing/2014/main" id="{1FBBD255-F69A-1E30-A0E2-E3D2B180C7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4825" y="6287733"/>
            <a:ext cx="11225719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“+”, means the TR4 was observed in the banana plant tissue; “-”, means the TR4 was not observed.</a:t>
            </a:r>
            <a:r>
              <a:rPr kumimoji="0" lang="en-US" altLang="zh-CN" sz="1400" b="0" i="0" u="sng" strike="noStrike" cap="none" normalizeH="0" baseline="0" dirty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“T”, means the root or corm were transverse-sectioned. “L”, means the root or corm were cut longitudinally.</a:t>
            </a:r>
            <a:endParaRPr kumimoji="0" lang="en-US" altLang="zh-CN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642836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7BF94B5-0E9E-98B3-DE52-EA01910B4B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5386011"/>
              </p:ext>
            </p:extLst>
          </p:nvPr>
        </p:nvGraphicFramePr>
        <p:xfrm>
          <a:off x="1780050" y="1118770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5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1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1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0.6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6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24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3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326BFF00-6CEB-97FB-9B21-071E8E5F19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00165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F740FC-73EB-E6AD-8492-4BBE666C60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11010508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58315E6A-9BDB-9161-D67E-4769ABAECF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4146589"/>
              </p:ext>
            </p:extLst>
          </p:nvPr>
        </p:nvGraphicFramePr>
        <p:xfrm>
          <a:off x="1628775" y="1513677"/>
          <a:ext cx="8139151" cy="474473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602702232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212531917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792614287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638716910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413273791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830744964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309745834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5768083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 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69563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852616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383315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2 </a:t>
                      </a:r>
                      <a:endParaRPr lang="en-US" altLang="zh-CN" sz="1800" b="0" i="0" u="none" strike="noStrike" dirty="0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5519647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 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7968567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8154007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334822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9311973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 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9034543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853213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807920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6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 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900736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 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</a:t>
                      </a:r>
                      <a:endParaRPr lang="en-US" altLang="zh-CN" sz="1800" b="0" i="0" u="none" strike="noStrike" dirty="0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93960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403666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528770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5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1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53221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184073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7978C7DC-9996-C14B-7CB0-7F721D45EB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0883001"/>
              </p:ext>
            </p:extLst>
          </p:nvPr>
        </p:nvGraphicFramePr>
        <p:xfrm>
          <a:off x="1876425" y="1056633"/>
          <a:ext cx="8139151" cy="474473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 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</a:t>
                      </a:r>
                      <a:endParaRPr lang="en-US" altLang="zh-CN" sz="1800" b="0" i="0" u="none" strike="noStrike" dirty="0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 </a:t>
                      </a:r>
                      <a:endParaRPr lang="en-US" altLang="zh-CN" sz="1800" b="0" i="0" u="none" strike="noStrike" dirty="0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</a:t>
                      </a:r>
                      <a:endParaRPr lang="en-US" altLang="zh-CN" sz="1800" b="0" i="0" u="none" strike="noStrike" dirty="0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 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 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3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1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08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2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 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</a:t>
                      </a:r>
                      <a:endParaRPr lang="en-US" altLang="zh-CN" sz="1800" b="0" i="0" u="none" strike="noStrike">
                        <a:solidFill>
                          <a:srgbClr val="993300"/>
                        </a:solidFill>
                        <a:effectLst/>
                        <a:latin typeface="Times New Roman" panose="02020603050405020304" pitchFamily="18" charset="0"/>
                        <a:ea typeface="MingLiU" panose="02020509000000000000" pitchFamily="49" charset="-12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  <a:endParaRPr lang="en-US" sz="1800" b="0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Pase</a:t>
                      </a:r>
                      <a:endParaRPr lang="en-US" sz="1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3EB86722-AAB1-F0A0-9807-DFD71BA895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08577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610CE8BE-64B9-779F-61A1-E22635FCA5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6036288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8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.7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.2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8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9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1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4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5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4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4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6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FA196D4A-DAD4-56B9-347A-5FD2F8389F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2"/>
            <a:ext cx="5827827" cy="1074418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29025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580EE4E-FE68-A216-8774-39BE4ED4BE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2579086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.7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2.9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.3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0.2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.3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9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4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0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.9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5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6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.11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.31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SS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65A1B89F-9ED6-7456-D8D5-81937129A3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21892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BDD46DD3-020E-40BA-3128-2051574A30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5196960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4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8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6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8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3.9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4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24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9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6948D075-DBBA-89D6-4945-F24770C80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34947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130640A8-78FE-A188-C555-71B9D15D6F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5395625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9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3.3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5.0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46.6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9.7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44.2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7.9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4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4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9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8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5.9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3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72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7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unjiao No.1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E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4136BAE0-B989-1D16-BC33-E55370054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 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46989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C6322FE5-A52C-5BE4-C54F-535DE851A5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1496989"/>
              </p:ext>
            </p:extLst>
          </p:nvPr>
        </p:nvGraphicFramePr>
        <p:xfrm>
          <a:off x="1876425" y="1056633"/>
          <a:ext cx="8139151" cy="47901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3476">
                  <a:extLst>
                    <a:ext uri="{9D8B030D-6E8A-4147-A177-3AD203B41FA5}">
                      <a16:colId xmlns:a16="http://schemas.microsoft.com/office/drawing/2014/main" val="22201760"/>
                    </a:ext>
                  </a:extLst>
                </a:gridCol>
                <a:gridCol w="1352550">
                  <a:extLst>
                    <a:ext uri="{9D8B030D-6E8A-4147-A177-3AD203B41FA5}">
                      <a16:colId xmlns:a16="http://schemas.microsoft.com/office/drawing/2014/main" val="2317936642"/>
                    </a:ext>
                  </a:extLst>
                </a:gridCol>
                <a:gridCol w="1157249">
                  <a:extLst>
                    <a:ext uri="{9D8B030D-6E8A-4147-A177-3AD203B41FA5}">
                      <a16:colId xmlns:a16="http://schemas.microsoft.com/office/drawing/2014/main" val="1988110539"/>
                    </a:ext>
                  </a:extLst>
                </a:gridCol>
                <a:gridCol w="1576426">
                  <a:extLst>
                    <a:ext uri="{9D8B030D-6E8A-4147-A177-3AD203B41FA5}">
                      <a16:colId xmlns:a16="http://schemas.microsoft.com/office/drawing/2014/main" val="2030418467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074807738"/>
                    </a:ext>
                  </a:extLst>
                </a:gridCol>
                <a:gridCol w="1276350">
                  <a:extLst>
                    <a:ext uri="{9D8B030D-6E8A-4147-A177-3AD203B41FA5}">
                      <a16:colId xmlns:a16="http://schemas.microsoft.com/office/drawing/2014/main" val="242684036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222987053"/>
                    </a:ext>
                  </a:extLst>
                </a:gridCol>
              </a:tblGrid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im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reatment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 error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el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tivars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82" marR="4782" marT="4782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9360854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6523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3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086556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9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801762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2.3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9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807310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103225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792267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3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37951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d</a:t>
                      </a:r>
                    </a:p>
                  </a:txBody>
                  <a:tcPr marL="7620" marR="7620" marT="7620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92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1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524022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92842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6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2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414954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6492018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55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7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8832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K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00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76019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0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2691175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1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1.76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33 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620" marR="7620" marT="762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0340431"/>
                  </a:ext>
                </a:extLst>
              </a:tr>
              <a:tr h="275294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d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4+R2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49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CN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ingLiU" panose="02020509000000000000" pitchFamily="49" charset="-120"/>
                          <a:cs typeface="Times New Roman" panose="02020603050405020304" pitchFamily="18" charset="0"/>
                        </a:rPr>
                        <a:t>0.14 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</a:t>
                      </a:r>
                    </a:p>
                  </a:txBody>
                  <a:tcPr marL="7620" marR="7620" marT="762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azilian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</a:p>
                  </a:txBody>
                  <a:tcPr marL="7620" marR="7620" marT="762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742977"/>
                  </a:ext>
                </a:extLst>
              </a:tr>
            </a:tbl>
          </a:graphicData>
        </a:graphic>
      </p:graphicFrame>
      <p:sp>
        <p:nvSpPr>
          <p:cNvPr id="2" name="标题 1">
            <a:extLst>
              <a:ext uri="{FF2B5EF4-FFF2-40B4-BE49-F238E27FC236}">
                <a16:creationId xmlns:a16="http://schemas.microsoft.com/office/drawing/2014/main" id="{B127DCBA-BE16-9B91-46C5-D4B4633A0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8775" y="-63193"/>
            <a:ext cx="8686800" cy="1325563"/>
          </a:xfrm>
        </p:spPr>
        <p:txBody>
          <a:bodyPr>
            <a:norm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l Table 3. Data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s</a:t>
            </a:r>
            <a:r>
              <a:rPr lang="zh-CN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(continued)</a:t>
            </a:r>
            <a:endParaRPr lang="zh-CN" altLang="en-US" sz="18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9708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89</TotalTime>
  <Words>3494</Words>
  <Application>Microsoft Office PowerPoint</Application>
  <PresentationFormat>宽屏</PresentationFormat>
  <Paragraphs>2393</Paragraphs>
  <Slides>2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5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 Supplemental Table 3. Data of gens expression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 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</vt:lpstr>
      <vt:lpstr> Supplemental Table 3. Data of gens expression (continued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8618854886035</dc:creator>
  <cp:lastModifiedBy>Zheng, Sijun (Alliance Bioversity-CIAT)</cp:lastModifiedBy>
  <cp:revision>28</cp:revision>
  <dcterms:created xsi:type="dcterms:W3CDTF">2022-11-07T02:39:58Z</dcterms:created>
  <dcterms:modified xsi:type="dcterms:W3CDTF">2023-01-16T03:18:32Z</dcterms:modified>
</cp:coreProperties>
</file>